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4E5A6CE-09F7-4782-A302-517E00B22A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8FC3362-41E9-40A8-8C07-3A8564F0BF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DCF392E-0923-4EC7-A468-7F5421C3D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4E91C9-5C72-4741-8525-DE6A3E853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4C225B5-E08A-47FC-8676-C7F2791EB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8744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D26D43-1436-4464-B127-60A6D57987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6C470E3-291A-4407-A595-6C58A8DD18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EC53EE7-FF48-4299-A4F6-DA59918E2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1103E08-60AF-40C3-94BC-60658B5BA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C791C1-4114-46AE-82B7-513A631B8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4538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F3854FE-FA06-4CEC-82A8-6BF84ABFEE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78D93CC-00F2-4833-B2CE-848256D839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9464BAD-5A95-4D44-9C71-7277A52AD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87B2A9A-A0BF-490F-9727-245981A4D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F9F67A7-183B-45BD-BAB1-E27C869C5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132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C409DA-CBA5-4F7A-BEEA-309F2EBE8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0A56A2-0BF0-4B4F-98E0-C1E20A2235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6826F19-605C-4EDB-9B64-643FF7FF7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CE88A0-3150-4B07-AB51-424DCFC0E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8C0EE3B-0B76-42D1-94FA-C73174719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193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AF4CEDA-CC88-448B-BE9A-792CAAFE4F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282F732-88A7-4D5C-BC5A-0B31C1C444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00D23A-DEE7-46A0-A1A1-69EFF9F3C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431CDE1-7E07-4059-B56F-C0C085209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8A8D9DA-3A7A-4C73-BE3C-EB6E68286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911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7BF296-CBCE-42A0-A2DA-0A7A4E2BD7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718F691-DEFF-47F5-8591-0E4069A324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57F7880-8BDE-4860-8F11-9F2D3E0250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3148FF3-5390-43B3-9176-1FF3CB113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9B86117-9B3F-4C82-83C0-D4866612F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0E6444F-663F-46F1-A244-BE6E598DA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5414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2862F7-24DC-4E95-B6F4-652B74691D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0EA50FD-1F3D-4FDC-A9F6-197B787A8D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7432984-8CC1-4AA4-947B-636CCB71F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382E1BE-1C8A-4521-AC8E-CD042F8AB5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75EEEB4-60F0-44AF-8AEA-0FFCAF043D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23ED4FA7-49BA-4BA5-92CD-73E613031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EAB6082-E9DA-4219-8CDA-64C33D617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A9D14A1-3124-40B2-80C2-E4C8D95D9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5463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D0FB94-174E-4B09-9797-F2D15762B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49FD9CD-2492-4C4F-95E2-514AAA2C1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EBCD1BA-0C06-4F1C-B4DA-82F68BDD7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8ABD313-BD30-4EC9-92BF-18D5FCA37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8687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CFB7945-BB2B-4E07-A73C-603444025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2A44294-A078-43C0-99D8-E44031EA1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AB7475E-3A37-4B5E-8958-0BB2C9A44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492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6430A0-4169-4485-A805-CC21B3E4E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2E6F4DE-B6A4-4A3C-A8F5-4B53053875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2000DFF-4697-47D3-84B6-0856901316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C4692CE-D808-4623-8C7F-1C7244A36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1FA6214-F2D8-4FCA-96F2-D8D91F80B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3B0C90E-9469-40AD-8ADB-A5653B155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623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16BA95-D10A-4E0A-905A-16C5D71A4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6FA8D537-6C46-4A55-82E2-6AE90B8F47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53C0E94-2875-457E-9683-205876CFB1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2F5287E-4310-4FCB-BABF-FDDCB3B59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5DB8315-C5E7-48B4-B184-E5360359A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607BA29-86CE-4648-88CF-DE7C723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803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40F8BB3-BF9D-4DE6-B161-4B99AE08B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BEA37C2-712D-4D1B-8178-C481C30280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0A0E846-2E84-4904-8CBD-BDDF2661A1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8D060-D9A3-4E70-BE42-E1B5561BE0A6}" type="datetimeFigureOut">
              <a:rPr lang="ko-KR" altLang="en-US" smtClean="0"/>
              <a:t>2021-08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800AE51-EE8C-48C9-8996-B1F22ACC87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286D335-D17A-4DDB-93A4-E9EED42C74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3C564-299B-4A18-9C2C-28FEA8745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4785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C853C49-094F-48A3-96C7-94A8A0C0A999}"/>
              </a:ext>
            </a:extLst>
          </p:cNvPr>
          <p:cNvSpPr txBox="1"/>
          <p:nvPr/>
        </p:nvSpPr>
        <p:spPr>
          <a:xfrm>
            <a:off x="3048000" y="6581001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/>
            <a:r>
              <a:rPr lang="en-US" altLang="ko-KR" sz="1050" kern="100" baseline="300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*  </a:t>
            </a:r>
            <a:r>
              <a:rPr lang="en-US" altLang="ko-KR" sz="1200" kern="10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: P value (compared with DMSO) &gt;0.05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FCFDFA2D-2CCC-4A57-A040-FDB551E021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5570894"/>
              </p:ext>
            </p:extLst>
          </p:nvPr>
        </p:nvGraphicFramePr>
        <p:xfrm>
          <a:off x="3048000" y="-1"/>
          <a:ext cx="5738943" cy="6581002"/>
        </p:xfrm>
        <a:graphic>
          <a:graphicData uri="http://schemas.openxmlformats.org/drawingml/2006/table">
            <a:tbl>
              <a:tblPr firstRow="1" firstCol="1" bandRow="1"/>
              <a:tblGrid>
                <a:gridCol w="539103">
                  <a:extLst>
                    <a:ext uri="{9D8B030D-6E8A-4147-A177-3AD203B41FA5}">
                      <a16:colId xmlns:a16="http://schemas.microsoft.com/office/drawing/2014/main" val="1899206946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2246358241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1888069604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2781134810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99571498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334280410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4017420569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450459324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611513598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866130284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333157023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696630158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909334433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2602891198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1730014283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935042751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911776292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3290342718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1738552689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2345532699"/>
                    </a:ext>
                  </a:extLst>
                </a:gridCol>
                <a:gridCol w="259992">
                  <a:extLst>
                    <a:ext uri="{9D8B030D-6E8A-4147-A177-3AD203B41FA5}">
                      <a16:colId xmlns:a16="http://schemas.microsoft.com/office/drawing/2014/main" val="2317622794"/>
                    </a:ext>
                  </a:extLst>
                </a:gridCol>
              </a:tblGrid>
              <a:tr h="348789">
                <a:tc row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Drugs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ngle Cell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ulti-spheroi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5707294"/>
                  </a:ext>
                </a:extLst>
              </a:tr>
              <a:tr h="15407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trocyte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1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2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3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4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trocyte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1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2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3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 4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9876838"/>
                  </a:ext>
                </a:extLst>
              </a:tr>
              <a:tr h="34878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D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1438814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_DMSO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1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1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4302247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_Dacomitinib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0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5351543"/>
                  </a:ext>
                </a:extLst>
              </a:tr>
              <a:tr h="422403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_Axitinib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1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953489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_Cediranib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618535"/>
                  </a:ext>
                </a:extLst>
              </a:tr>
              <a:tr h="42390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_INCB28060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829606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_LEE011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1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753825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6_LY2835219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281281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_BGJ398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6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8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600623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_Nilotinib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2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8002939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_LGK-974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2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7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4221156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_Sotrastaurin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6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4096796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1_Vismodegib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5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171384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_PHA-665752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0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8732859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_TMZ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5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1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9663537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_Amoral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4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1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7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6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556302"/>
                  </a:ext>
                </a:extLst>
              </a:tr>
              <a:tr h="34878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</a:pPr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_Raloxi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3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1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2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8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2 </a:t>
                      </a:r>
                      <a:endParaRPr lang="ko-KR" sz="7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sz="600" kern="1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7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latinLnBrk="0">
                        <a:lnSpc>
                          <a:spcPct val="107000"/>
                        </a:lnSpc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 </a:t>
                      </a:r>
                      <a:endParaRPr lang="ko-KR" sz="7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124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02001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74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4</Words>
  <Application>Microsoft Office PowerPoint</Application>
  <PresentationFormat>와이드스크린</PresentationFormat>
  <Paragraphs>37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상윤</dc:creator>
  <cp:lastModifiedBy>이상윤</cp:lastModifiedBy>
  <cp:revision>1</cp:revision>
  <dcterms:created xsi:type="dcterms:W3CDTF">2021-08-01T02:56:46Z</dcterms:created>
  <dcterms:modified xsi:type="dcterms:W3CDTF">2021-08-01T02:58:35Z</dcterms:modified>
</cp:coreProperties>
</file>